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8" r:id="rId2"/>
  </p:sldIdLst>
  <p:sldSz cx="9144000" cy="6858000" type="screen4x3"/>
  <p:notesSz cx="6888163" cy="100203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985" autoAdjust="0"/>
    <p:restoredTop sz="94712" autoAdjust="0"/>
  </p:normalViewPr>
  <p:slideViewPr>
    <p:cSldViewPr snapToGrid="0">
      <p:cViewPr varScale="1">
        <p:scale>
          <a:sx n="105" d="100"/>
          <a:sy n="105" d="100"/>
        </p:scale>
        <p:origin x="1638" y="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2.8382635989486021E-2"/>
          <c:y val="0.17685185185185184"/>
          <c:w val="0.95859190394464455"/>
          <c:h val="0.51989100320793236"/>
        </c:manualLayout>
      </c:layout>
      <c:barChart>
        <c:barDir val="col"/>
        <c:grouping val="clustered"/>
        <c:varyColors val="0"/>
        <c:ser>
          <c:idx val="1"/>
          <c:order val="0"/>
          <c:tx>
            <c:v>21</c:v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'All weekly conc.'!$A$2:$A$78</c:f>
              <c:strCache>
                <c:ptCount val="77"/>
                <c:pt idx="0">
                  <c:v>1st week, Sep.,2014</c:v>
                </c:pt>
                <c:pt idx="1">
                  <c:v>2nd week</c:v>
                </c:pt>
                <c:pt idx="2">
                  <c:v>3rd week</c:v>
                </c:pt>
                <c:pt idx="3">
                  <c:v>4th week</c:v>
                </c:pt>
                <c:pt idx="4">
                  <c:v>1st week, Oct.</c:v>
                </c:pt>
                <c:pt idx="5">
                  <c:v>2nd week</c:v>
                </c:pt>
                <c:pt idx="6">
                  <c:v>1st week, Nov.</c:v>
                </c:pt>
                <c:pt idx="7">
                  <c:v>2nd week</c:v>
                </c:pt>
                <c:pt idx="8">
                  <c:v>3rd week</c:v>
                </c:pt>
                <c:pt idx="9">
                  <c:v>4th week</c:v>
                </c:pt>
                <c:pt idx="10">
                  <c:v>1st week, Dec.</c:v>
                </c:pt>
                <c:pt idx="11">
                  <c:v>2nd week</c:v>
                </c:pt>
                <c:pt idx="12">
                  <c:v>3rd week</c:v>
                </c:pt>
                <c:pt idx="13">
                  <c:v>4th week</c:v>
                </c:pt>
                <c:pt idx="14">
                  <c:v>1st week, Jan., 2015</c:v>
                </c:pt>
                <c:pt idx="15">
                  <c:v>2nd week</c:v>
                </c:pt>
                <c:pt idx="16">
                  <c:v>3rd week</c:v>
                </c:pt>
                <c:pt idx="17">
                  <c:v>1st week, Feb.</c:v>
                </c:pt>
                <c:pt idx="18">
                  <c:v>2nd week</c:v>
                </c:pt>
                <c:pt idx="19">
                  <c:v>3rd week</c:v>
                </c:pt>
                <c:pt idx="20">
                  <c:v>4th week</c:v>
                </c:pt>
                <c:pt idx="21">
                  <c:v>1st week, Mar.</c:v>
                </c:pt>
                <c:pt idx="22">
                  <c:v>2nd week</c:v>
                </c:pt>
                <c:pt idx="23">
                  <c:v>3rd week</c:v>
                </c:pt>
                <c:pt idx="24">
                  <c:v>4th week</c:v>
                </c:pt>
                <c:pt idx="25">
                  <c:v>1st week, Apr.</c:v>
                </c:pt>
                <c:pt idx="26">
                  <c:v>2nd week</c:v>
                </c:pt>
                <c:pt idx="27">
                  <c:v>3rd week</c:v>
                </c:pt>
                <c:pt idx="28">
                  <c:v>4th week</c:v>
                </c:pt>
                <c:pt idx="29">
                  <c:v>1st week, May</c:v>
                </c:pt>
                <c:pt idx="30">
                  <c:v>2nd week</c:v>
                </c:pt>
                <c:pt idx="31">
                  <c:v>3rd week</c:v>
                </c:pt>
                <c:pt idx="32">
                  <c:v>1st week, Jun.</c:v>
                </c:pt>
                <c:pt idx="33">
                  <c:v>2nd week</c:v>
                </c:pt>
                <c:pt idx="34">
                  <c:v>3rd week</c:v>
                </c:pt>
                <c:pt idx="35">
                  <c:v>4th week</c:v>
                </c:pt>
                <c:pt idx="36">
                  <c:v>1st week, Jul.</c:v>
                </c:pt>
                <c:pt idx="37">
                  <c:v>2nd week</c:v>
                </c:pt>
                <c:pt idx="38">
                  <c:v>3rd week</c:v>
                </c:pt>
                <c:pt idx="39">
                  <c:v>4th week</c:v>
                </c:pt>
                <c:pt idx="40">
                  <c:v>1st week, Aug.</c:v>
                </c:pt>
                <c:pt idx="41">
                  <c:v>2nd week</c:v>
                </c:pt>
                <c:pt idx="42">
                  <c:v>3rd week</c:v>
                </c:pt>
                <c:pt idx="43">
                  <c:v>4th week</c:v>
                </c:pt>
                <c:pt idx="44">
                  <c:v>1st week, Sep.</c:v>
                </c:pt>
                <c:pt idx="45">
                  <c:v>2nd week</c:v>
                </c:pt>
                <c:pt idx="46">
                  <c:v>3rd week</c:v>
                </c:pt>
                <c:pt idx="47">
                  <c:v>1st week, Oct.</c:v>
                </c:pt>
                <c:pt idx="48">
                  <c:v>2nd week</c:v>
                </c:pt>
                <c:pt idx="49">
                  <c:v>3rd week</c:v>
                </c:pt>
                <c:pt idx="50">
                  <c:v>4th week</c:v>
                </c:pt>
                <c:pt idx="51">
                  <c:v>1st week, Nov.</c:v>
                </c:pt>
                <c:pt idx="52">
                  <c:v>2nd week</c:v>
                </c:pt>
                <c:pt idx="53">
                  <c:v>3rd week</c:v>
                </c:pt>
                <c:pt idx="54">
                  <c:v>4th week</c:v>
                </c:pt>
                <c:pt idx="55">
                  <c:v>1st week, Dec.</c:v>
                </c:pt>
                <c:pt idx="56">
                  <c:v>2nd week</c:v>
                </c:pt>
                <c:pt idx="57">
                  <c:v>3rd week</c:v>
                </c:pt>
                <c:pt idx="58">
                  <c:v>1st week, Jan., 2016</c:v>
                </c:pt>
                <c:pt idx="59">
                  <c:v>2nd week</c:v>
                </c:pt>
                <c:pt idx="60">
                  <c:v>3rd week</c:v>
                </c:pt>
                <c:pt idx="61">
                  <c:v>4th week</c:v>
                </c:pt>
                <c:pt idx="62">
                  <c:v>1st week, Feb.</c:v>
                </c:pt>
                <c:pt idx="63">
                  <c:v>2nd week</c:v>
                </c:pt>
                <c:pt idx="64">
                  <c:v>3rd week</c:v>
                </c:pt>
                <c:pt idx="65">
                  <c:v>4th week</c:v>
                </c:pt>
                <c:pt idx="66">
                  <c:v>1st week, Mar.</c:v>
                </c:pt>
                <c:pt idx="67">
                  <c:v>2nd week</c:v>
                </c:pt>
                <c:pt idx="68">
                  <c:v>3rd week</c:v>
                </c:pt>
                <c:pt idx="69">
                  <c:v>4th week</c:v>
                </c:pt>
                <c:pt idx="70">
                  <c:v>1st week, Apr.</c:v>
                </c:pt>
                <c:pt idx="71">
                  <c:v>2nd week</c:v>
                </c:pt>
                <c:pt idx="72">
                  <c:v>3rd week</c:v>
                </c:pt>
                <c:pt idx="73">
                  <c:v>4th week</c:v>
                </c:pt>
                <c:pt idx="74">
                  <c:v>1st week, May</c:v>
                </c:pt>
                <c:pt idx="75">
                  <c:v>2nd week</c:v>
                </c:pt>
                <c:pt idx="76">
                  <c:v>3rd week</c:v>
                </c:pt>
              </c:strCache>
            </c:strRef>
          </c:cat>
          <c:val>
            <c:numRef>
              <c:f>'All weekly conc.'!$B$2:$B$78</c:f>
              <c:numCache>
                <c:formatCode>General</c:formatCode>
                <c:ptCount val="77"/>
                <c:pt idx="0">
                  <c:v>10.813706621163119</c:v>
                </c:pt>
                <c:pt idx="1">
                  <c:v>10.119248397785672</c:v>
                </c:pt>
                <c:pt idx="2">
                  <c:v>11.805789797416615</c:v>
                </c:pt>
                <c:pt idx="3">
                  <c:v>10.714498303537768</c:v>
                </c:pt>
                <c:pt idx="4">
                  <c:v>11.11133157403917</c:v>
                </c:pt>
                <c:pt idx="5">
                  <c:v>12.698664656044764</c:v>
                </c:pt>
                <c:pt idx="6">
                  <c:v>10.218456715411021</c:v>
                </c:pt>
                <c:pt idx="7">
                  <c:v>15.079664279053157</c:v>
                </c:pt>
                <c:pt idx="8">
                  <c:v>16.170955772931983</c:v>
                </c:pt>
                <c:pt idx="9">
                  <c:v>13.393122879422235</c:v>
                </c:pt>
                <c:pt idx="10">
                  <c:v>9.7224151272842576</c:v>
                </c:pt>
                <c:pt idx="11">
                  <c:v>11.508164844540577</c:v>
                </c:pt>
                <c:pt idx="12">
                  <c:v>10.416873350661762</c:v>
                </c:pt>
                <c:pt idx="13">
                  <c:v>10.813706621163119</c:v>
                </c:pt>
                <c:pt idx="14">
                  <c:v>9.1270746733598624</c:v>
                </c:pt>
                <c:pt idx="15">
                  <c:v>12.301831385543377</c:v>
                </c:pt>
                <c:pt idx="16">
                  <c:v>17.063830631560123</c:v>
                </c:pt>
                <c:pt idx="17">
                  <c:v>18.353538760689705</c:v>
                </c:pt>
                <c:pt idx="18">
                  <c:v>19.345621936943221</c:v>
                </c:pt>
                <c:pt idx="19">
                  <c:v>7.5398321395265855</c:v>
                </c:pt>
                <c:pt idx="20">
                  <c:v>18.948788666441821</c:v>
                </c:pt>
                <c:pt idx="21">
                  <c:v>14.583622690926431</c:v>
                </c:pt>
                <c:pt idx="22">
                  <c:v>19.047996984067161</c:v>
                </c:pt>
                <c:pt idx="23">
                  <c:v>25.79416258259095</c:v>
                </c:pt>
                <c:pt idx="24">
                  <c:v>19.940871842695298</c:v>
                </c:pt>
                <c:pt idx="25">
                  <c:v>9.1271652215321826</c:v>
                </c:pt>
                <c:pt idx="26">
                  <c:v>11.111331574039134</c:v>
                </c:pt>
                <c:pt idx="27">
                  <c:v>23.413162959582511</c:v>
                </c:pt>
                <c:pt idx="28">
                  <c:v>32.341911545864058</c:v>
                </c:pt>
                <c:pt idx="29">
                  <c:v>21.428996607075515</c:v>
                </c:pt>
                <c:pt idx="30">
                  <c:v>8.4327069981547229</c:v>
                </c:pt>
                <c:pt idx="31">
                  <c:v>19.940871842695255</c:v>
                </c:pt>
                <c:pt idx="32">
                  <c:v>11.508164844540577</c:v>
                </c:pt>
                <c:pt idx="33">
                  <c:v>18.750372031191059</c:v>
                </c:pt>
                <c:pt idx="34">
                  <c:v>13.789956149923633</c:v>
                </c:pt>
                <c:pt idx="35">
                  <c:v>11.508164844540577</c:v>
                </c:pt>
                <c:pt idx="36">
                  <c:v>12.301831385543331</c:v>
                </c:pt>
                <c:pt idx="37">
                  <c:v>9.0625640583025042</c:v>
                </c:pt>
                <c:pt idx="38">
                  <c:v>7.1429988690251855</c:v>
                </c:pt>
                <c:pt idx="39">
                  <c:v>14.186789420425031</c:v>
                </c:pt>
                <c:pt idx="40">
                  <c:v>21.627413242326238</c:v>
                </c:pt>
                <c:pt idx="41">
                  <c:v>14.88124764380245</c:v>
                </c:pt>
                <c:pt idx="42">
                  <c:v>7.7382487747773059</c:v>
                </c:pt>
                <c:pt idx="43">
                  <c:v>9.6232068096589209</c:v>
                </c:pt>
                <c:pt idx="44">
                  <c:v>6.150915692771683</c:v>
                </c:pt>
                <c:pt idx="45">
                  <c:v>10.51608166828707</c:v>
                </c:pt>
                <c:pt idx="46">
                  <c:v>7.3414155042758633</c:v>
                </c:pt>
                <c:pt idx="47">
                  <c:v>10.218456715410996</c:v>
                </c:pt>
                <c:pt idx="48">
                  <c:v>17.956705490188259</c:v>
                </c:pt>
                <c:pt idx="49">
                  <c:v>18.353538760689705</c:v>
                </c:pt>
                <c:pt idx="50">
                  <c:v>15.972539137681308</c:v>
                </c:pt>
                <c:pt idx="51">
                  <c:v>10.119248397785658</c:v>
                </c:pt>
                <c:pt idx="52">
                  <c:v>7.7382487747773059</c:v>
                </c:pt>
                <c:pt idx="53">
                  <c:v>9.9208317625349789</c:v>
                </c:pt>
                <c:pt idx="54">
                  <c:v>10.317665033036379</c:v>
                </c:pt>
                <c:pt idx="55">
                  <c:v>10.218355340826815</c:v>
                </c:pt>
                <c:pt idx="56">
                  <c:v>10.615289985912396</c:v>
                </c:pt>
                <c:pt idx="57">
                  <c:v>10.615289985912396</c:v>
                </c:pt>
                <c:pt idx="58">
                  <c:v>12.202623067918038</c:v>
                </c:pt>
                <c:pt idx="59">
                  <c:v>10.615184674451111</c:v>
                </c:pt>
                <c:pt idx="60">
                  <c:v>10.813706621163119</c:v>
                </c:pt>
                <c:pt idx="61">
                  <c:v>14.087581102799652</c:v>
                </c:pt>
                <c:pt idx="62">
                  <c:v>12.933531992384736</c:v>
                </c:pt>
                <c:pt idx="63">
                  <c:v>9.3255818567829039</c:v>
                </c:pt>
                <c:pt idx="64">
                  <c:v>13.492331197047573</c:v>
                </c:pt>
                <c:pt idx="65">
                  <c:v>20.436913430822038</c:v>
                </c:pt>
                <c:pt idx="66">
                  <c:v>21.825829877576911</c:v>
                </c:pt>
                <c:pt idx="67">
                  <c:v>10.317665033036379</c:v>
                </c:pt>
                <c:pt idx="68">
                  <c:v>15.774122502430584</c:v>
                </c:pt>
                <c:pt idx="69">
                  <c:v>15.377289231929232</c:v>
                </c:pt>
                <c:pt idx="70">
                  <c:v>13.194706244171511</c:v>
                </c:pt>
                <c:pt idx="71">
                  <c:v>18.551955395940379</c:v>
                </c:pt>
                <c:pt idx="72">
                  <c:v>15.278080914303848</c:v>
                </c:pt>
                <c:pt idx="73">
                  <c:v>25.298120994464167</c:v>
                </c:pt>
                <c:pt idx="74">
                  <c:v>13.690612010039816</c:v>
                </c:pt>
                <c:pt idx="75">
                  <c:v>22.718704736205087</c:v>
                </c:pt>
                <c:pt idx="76">
                  <c:v>24.3060378182106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1F2-4463-88D7-1CCC087ED41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14875112"/>
        <c:axId val="314869624"/>
      </c:barChart>
      <c:catAx>
        <c:axId val="31487511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5400000" spcFirstLastPara="1" vertOverflow="ellipsis" wrap="square" anchor="ctr" anchorCtr="1"/>
          <a:lstStyle/>
          <a:p>
            <a:pPr>
              <a:defRPr lang="ja-JP" sz="7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314869624"/>
        <c:crosses val="autoZero"/>
        <c:auto val="0"/>
        <c:lblAlgn val="ctr"/>
        <c:lblOffset val="100"/>
        <c:noMultiLvlLbl val="0"/>
      </c:catAx>
      <c:valAx>
        <c:axId val="314869624"/>
        <c:scaling>
          <c:orientation val="minMax"/>
          <c:max val="4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314875112"/>
        <c:crosses val="autoZero"/>
        <c:crossBetween val="between"/>
        <c:majorUnit val="1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3.7342842281653528E-2"/>
          <c:y val="0.12020704134411014"/>
          <c:w val="0.94087020189474457"/>
          <c:h val="0.58756359556022097"/>
        </c:manualLayout>
      </c:layout>
      <c:barChart>
        <c:barDir val="col"/>
        <c:grouping val="clustered"/>
        <c:varyColors val="0"/>
        <c:ser>
          <c:idx val="1"/>
          <c:order val="0"/>
          <c:tx>
            <c:v>new</c:v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'All weekly conc.'!$A$2:$A$78</c:f>
              <c:strCache>
                <c:ptCount val="77"/>
                <c:pt idx="0">
                  <c:v>1st week, Sep.,2014</c:v>
                </c:pt>
                <c:pt idx="1">
                  <c:v>2nd week</c:v>
                </c:pt>
                <c:pt idx="2">
                  <c:v>3rd week</c:v>
                </c:pt>
                <c:pt idx="3">
                  <c:v>4th week</c:v>
                </c:pt>
                <c:pt idx="4">
                  <c:v>1st week, Oct.</c:v>
                </c:pt>
                <c:pt idx="5">
                  <c:v>2nd week</c:v>
                </c:pt>
                <c:pt idx="6">
                  <c:v>1st week, Nov.</c:v>
                </c:pt>
                <c:pt idx="7">
                  <c:v>2nd week</c:v>
                </c:pt>
                <c:pt idx="8">
                  <c:v>3rd week</c:v>
                </c:pt>
                <c:pt idx="9">
                  <c:v>4th week</c:v>
                </c:pt>
                <c:pt idx="10">
                  <c:v>1st week, Dec.</c:v>
                </c:pt>
                <c:pt idx="11">
                  <c:v>2nd week</c:v>
                </c:pt>
                <c:pt idx="12">
                  <c:v>3rd week</c:v>
                </c:pt>
                <c:pt idx="13">
                  <c:v>4th week</c:v>
                </c:pt>
                <c:pt idx="14">
                  <c:v>1st week, Jan., 2015</c:v>
                </c:pt>
                <c:pt idx="15">
                  <c:v>2nd week</c:v>
                </c:pt>
                <c:pt idx="16">
                  <c:v>3rd week</c:v>
                </c:pt>
                <c:pt idx="17">
                  <c:v>1st week, Feb.</c:v>
                </c:pt>
                <c:pt idx="18">
                  <c:v>2nd week</c:v>
                </c:pt>
                <c:pt idx="19">
                  <c:v>3rd week</c:v>
                </c:pt>
                <c:pt idx="20">
                  <c:v>4th week</c:v>
                </c:pt>
                <c:pt idx="21">
                  <c:v>1st week, Mar.</c:v>
                </c:pt>
                <c:pt idx="22">
                  <c:v>2nd week</c:v>
                </c:pt>
                <c:pt idx="23">
                  <c:v>3rd week</c:v>
                </c:pt>
                <c:pt idx="24">
                  <c:v>4th week</c:v>
                </c:pt>
                <c:pt idx="25">
                  <c:v>1st week, Apr.</c:v>
                </c:pt>
                <c:pt idx="26">
                  <c:v>2nd week</c:v>
                </c:pt>
                <c:pt idx="27">
                  <c:v>3rd week</c:v>
                </c:pt>
                <c:pt idx="28">
                  <c:v>4th week</c:v>
                </c:pt>
                <c:pt idx="29">
                  <c:v>1st week, May</c:v>
                </c:pt>
                <c:pt idx="30">
                  <c:v>2nd week</c:v>
                </c:pt>
                <c:pt idx="31">
                  <c:v>3rd week</c:v>
                </c:pt>
                <c:pt idx="32">
                  <c:v>1st week, Jun.</c:v>
                </c:pt>
                <c:pt idx="33">
                  <c:v>2nd week</c:v>
                </c:pt>
                <c:pt idx="34">
                  <c:v>3rd week</c:v>
                </c:pt>
                <c:pt idx="35">
                  <c:v>4th week</c:v>
                </c:pt>
                <c:pt idx="36">
                  <c:v>1st week, Jul.</c:v>
                </c:pt>
                <c:pt idx="37">
                  <c:v>2nd week</c:v>
                </c:pt>
                <c:pt idx="38">
                  <c:v>3rd week</c:v>
                </c:pt>
                <c:pt idx="39">
                  <c:v>4th week</c:v>
                </c:pt>
                <c:pt idx="40">
                  <c:v>1st week, Aug.</c:v>
                </c:pt>
                <c:pt idx="41">
                  <c:v>2nd week</c:v>
                </c:pt>
                <c:pt idx="42">
                  <c:v>3rd week</c:v>
                </c:pt>
                <c:pt idx="43">
                  <c:v>4th week</c:v>
                </c:pt>
                <c:pt idx="44">
                  <c:v>1st week, Sep.</c:v>
                </c:pt>
                <c:pt idx="45">
                  <c:v>2nd week</c:v>
                </c:pt>
                <c:pt idx="46">
                  <c:v>3rd week</c:v>
                </c:pt>
                <c:pt idx="47">
                  <c:v>1st week, Oct.</c:v>
                </c:pt>
                <c:pt idx="48">
                  <c:v>2nd week</c:v>
                </c:pt>
                <c:pt idx="49">
                  <c:v>3rd week</c:v>
                </c:pt>
                <c:pt idx="50">
                  <c:v>4th week</c:v>
                </c:pt>
                <c:pt idx="51">
                  <c:v>1st week, Nov.</c:v>
                </c:pt>
                <c:pt idx="52">
                  <c:v>2nd week</c:v>
                </c:pt>
                <c:pt idx="53">
                  <c:v>3rd week</c:v>
                </c:pt>
                <c:pt idx="54">
                  <c:v>4th week</c:v>
                </c:pt>
                <c:pt idx="55">
                  <c:v>1st week, Dec.</c:v>
                </c:pt>
                <c:pt idx="56">
                  <c:v>2nd week</c:v>
                </c:pt>
                <c:pt idx="57">
                  <c:v>3rd week</c:v>
                </c:pt>
                <c:pt idx="58">
                  <c:v>1st week, Jan., 2016</c:v>
                </c:pt>
                <c:pt idx="59">
                  <c:v>2nd week</c:v>
                </c:pt>
                <c:pt idx="60">
                  <c:v>3rd week</c:v>
                </c:pt>
                <c:pt idx="61">
                  <c:v>4th week</c:v>
                </c:pt>
                <c:pt idx="62">
                  <c:v>1st week, Feb.</c:v>
                </c:pt>
                <c:pt idx="63">
                  <c:v>2nd week</c:v>
                </c:pt>
                <c:pt idx="64">
                  <c:v>3rd week</c:v>
                </c:pt>
                <c:pt idx="65">
                  <c:v>4th week</c:v>
                </c:pt>
                <c:pt idx="66">
                  <c:v>1st week, Mar.</c:v>
                </c:pt>
                <c:pt idx="67">
                  <c:v>2nd week</c:v>
                </c:pt>
                <c:pt idx="68">
                  <c:v>3rd week</c:v>
                </c:pt>
                <c:pt idx="69">
                  <c:v>4th week</c:v>
                </c:pt>
                <c:pt idx="70">
                  <c:v>1st week, Apr.</c:v>
                </c:pt>
                <c:pt idx="71">
                  <c:v>2nd week</c:v>
                </c:pt>
                <c:pt idx="72">
                  <c:v>3rd week</c:v>
                </c:pt>
                <c:pt idx="73">
                  <c:v>4th week</c:v>
                </c:pt>
                <c:pt idx="74">
                  <c:v>1st week, May</c:v>
                </c:pt>
                <c:pt idx="75">
                  <c:v>2nd week</c:v>
                </c:pt>
                <c:pt idx="76">
                  <c:v>3rd week</c:v>
                </c:pt>
              </c:strCache>
            </c:strRef>
          </c:cat>
          <c:val>
            <c:numRef>
              <c:f>'All weekly conc.'!$N$2:$N$78</c:f>
              <c:numCache>
                <c:formatCode>General</c:formatCode>
                <c:ptCount val="77"/>
                <c:pt idx="0">
                  <c:v>7.8374570924026283</c:v>
                </c:pt>
                <c:pt idx="1">
                  <c:v>6.5477489632730812</c:v>
                </c:pt>
                <c:pt idx="2">
                  <c:v>7.0437905513998293</c:v>
                </c:pt>
                <c:pt idx="3">
                  <c:v>8.1350820452786774</c:v>
                </c:pt>
                <c:pt idx="4">
                  <c:v>9.5239984920335718</c:v>
                </c:pt>
                <c:pt idx="5">
                  <c:v>8.2342903629040265</c:v>
                </c:pt>
                <c:pt idx="6">
                  <c:v>8.4327069981547247</c:v>
                </c:pt>
                <c:pt idx="7">
                  <c:v>7.7382487747772846</c:v>
                </c:pt>
                <c:pt idx="8">
                  <c:v>7.7382487747772846</c:v>
                </c:pt>
                <c:pt idx="9">
                  <c:v>5.4564574693942278</c:v>
                </c:pt>
                <c:pt idx="10">
                  <c:v>3.8691243873886312</c:v>
                </c:pt>
                <c:pt idx="11">
                  <c:v>4.464374293140752</c:v>
                </c:pt>
                <c:pt idx="12">
                  <c:v>4.0675410226393529</c:v>
                </c:pt>
                <c:pt idx="13">
                  <c:v>5.1588325165181894</c:v>
                </c:pt>
                <c:pt idx="14">
                  <c:v>3.5714640026190767</c:v>
                </c:pt>
                <c:pt idx="15">
                  <c:v>8.2342903629040229</c:v>
                </c:pt>
                <c:pt idx="16">
                  <c:v>8.1350820452786845</c:v>
                </c:pt>
                <c:pt idx="17">
                  <c:v>4.6627909283914297</c:v>
                </c:pt>
                <c:pt idx="18">
                  <c:v>7.2422071866505258</c:v>
                </c:pt>
                <c:pt idx="19">
                  <c:v>4.7619992460167904</c:v>
                </c:pt>
                <c:pt idx="20">
                  <c:v>23.809996230083932</c:v>
                </c:pt>
                <c:pt idx="21">
                  <c:v>7.2422071866505462</c:v>
                </c:pt>
                <c:pt idx="22">
                  <c:v>6.646957280898425</c:v>
                </c:pt>
                <c:pt idx="23">
                  <c:v>11.706581479791277</c:v>
                </c:pt>
                <c:pt idx="24">
                  <c:v>8.6311236334054229</c:v>
                </c:pt>
                <c:pt idx="25">
                  <c:v>4.3651659755153913</c:v>
                </c:pt>
                <c:pt idx="26">
                  <c:v>5.1588325165181894</c:v>
                </c:pt>
                <c:pt idx="27">
                  <c:v>13.889164467548961</c:v>
                </c:pt>
                <c:pt idx="28">
                  <c:v>13.29391456179685</c:v>
                </c:pt>
                <c:pt idx="29">
                  <c:v>10.119248397785681</c:v>
                </c:pt>
                <c:pt idx="30">
                  <c:v>6.8453739161491249</c:v>
                </c:pt>
                <c:pt idx="31">
                  <c:v>5.4564574693942278</c:v>
                </c:pt>
                <c:pt idx="32">
                  <c:v>5.9524990575209662</c:v>
                </c:pt>
                <c:pt idx="33">
                  <c:v>10.119248397785681</c:v>
                </c:pt>
                <c:pt idx="34">
                  <c:v>7.837457092402623</c:v>
                </c:pt>
                <c:pt idx="35">
                  <c:v>5.5556657870195671</c:v>
                </c:pt>
                <c:pt idx="36">
                  <c:v>6.3493323280223875</c:v>
                </c:pt>
                <c:pt idx="37">
                  <c:v>10.03355306454919</c:v>
                </c:pt>
                <c:pt idx="38">
                  <c:v>7.4406238219012248</c:v>
                </c:pt>
                <c:pt idx="39">
                  <c:v>11.706581479791277</c:v>
                </c:pt>
                <c:pt idx="40">
                  <c:v>9.027956903906821</c:v>
                </c:pt>
                <c:pt idx="41">
                  <c:v>5.8532907398956278</c:v>
                </c:pt>
                <c:pt idx="42">
                  <c:v>8.8295402686561211</c:v>
                </c:pt>
                <c:pt idx="43">
                  <c:v>8.8295402686561211</c:v>
                </c:pt>
                <c:pt idx="44">
                  <c:v>7.9366654100279774</c:v>
                </c:pt>
                <c:pt idx="45">
                  <c:v>6.150915692771683</c:v>
                </c:pt>
                <c:pt idx="46">
                  <c:v>4.3651659755153913</c:v>
                </c:pt>
                <c:pt idx="47">
                  <c:v>9.1271652215321826</c:v>
                </c:pt>
                <c:pt idx="48">
                  <c:v>12.004206432667315</c:v>
                </c:pt>
                <c:pt idx="49">
                  <c:v>7.7382487747772624</c:v>
                </c:pt>
                <c:pt idx="50">
                  <c:v>12.797872973670113</c:v>
                </c:pt>
                <c:pt idx="51">
                  <c:v>4.4643742931407306</c:v>
                </c:pt>
                <c:pt idx="52">
                  <c:v>5.2580408341435287</c:v>
                </c:pt>
                <c:pt idx="53">
                  <c:v>7.3414155042758633</c:v>
                </c:pt>
                <c:pt idx="54">
                  <c:v>4.3651659755153691</c:v>
                </c:pt>
                <c:pt idx="55">
                  <c:v>6.4484766713955439</c:v>
                </c:pt>
                <c:pt idx="56">
                  <c:v>5.6548741046449278</c:v>
                </c:pt>
                <c:pt idx="57">
                  <c:v>3.8691243873886312</c:v>
                </c:pt>
                <c:pt idx="58">
                  <c:v>5.2580408341435287</c:v>
                </c:pt>
                <c:pt idx="59">
                  <c:v>2.3809760017460513</c:v>
                </c:pt>
                <c:pt idx="60">
                  <c:v>3.5714994345125928</c:v>
                </c:pt>
                <c:pt idx="61">
                  <c:v>5.5556657870195885</c:v>
                </c:pt>
                <c:pt idx="62">
                  <c:v>5.7942223325883448</c:v>
                </c:pt>
                <c:pt idx="63">
                  <c:v>4.3651659755153691</c:v>
                </c:pt>
                <c:pt idx="64">
                  <c:v>7.6390404571519239</c:v>
                </c:pt>
                <c:pt idx="65">
                  <c:v>10.020040080160319</c:v>
                </c:pt>
                <c:pt idx="66">
                  <c:v>14.28599773805035</c:v>
                </c:pt>
                <c:pt idx="67">
                  <c:v>3.9683327050139705</c:v>
                </c:pt>
                <c:pt idx="68">
                  <c:v>8.4327069981547229</c:v>
                </c:pt>
                <c:pt idx="69">
                  <c:v>6.646957280898425</c:v>
                </c:pt>
                <c:pt idx="70">
                  <c:v>5.1588325165181894</c:v>
                </c:pt>
                <c:pt idx="71">
                  <c:v>9.027956903906821</c:v>
                </c:pt>
                <c:pt idx="72">
                  <c:v>11.607373162165917</c:v>
                </c:pt>
                <c:pt idx="73">
                  <c:v>15.079664279053148</c:v>
                </c:pt>
                <c:pt idx="74">
                  <c:v>7.043720671832058</c:v>
                </c:pt>
                <c:pt idx="75">
                  <c:v>6.6469572808984303</c:v>
                </c:pt>
                <c:pt idx="76">
                  <c:v>6.84537391614913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F39-46AB-9060-92097C4A73F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14871584"/>
        <c:axId val="314873936"/>
      </c:barChart>
      <c:catAx>
        <c:axId val="31487158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5400000" spcFirstLastPara="1" vertOverflow="ellipsis" wrap="square" anchor="ctr" anchorCtr="1"/>
          <a:lstStyle/>
          <a:p>
            <a:pPr>
              <a:defRPr lang="ja-JP" sz="7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314873936"/>
        <c:crosses val="autoZero"/>
        <c:auto val="1"/>
        <c:lblAlgn val="ctr"/>
        <c:lblOffset val="100"/>
        <c:noMultiLvlLbl val="0"/>
      </c:catAx>
      <c:valAx>
        <c:axId val="31487393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0" spcFirstLastPara="1" vertOverflow="ellipsis" wrap="square" anchor="ctr" anchorCtr="1"/>
          <a:lstStyle/>
          <a:p>
            <a:pPr>
              <a:defRPr lang="ja-JP" sz="12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314871584"/>
        <c:crosses val="autoZero"/>
        <c:crossBetween val="between"/>
        <c:majorUnit val="7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84871" cy="502755"/>
          </a:xfrm>
          <a:prstGeom prst="rect">
            <a:avLst/>
          </a:prstGeom>
        </p:spPr>
        <p:txBody>
          <a:bodyPr vert="horz" lIns="96616" tIns="48308" rIns="96616" bIns="48308" rtlCol="0"/>
          <a:lstStyle>
            <a:lvl1pPr algn="l">
              <a:defRPr sz="1300"/>
            </a:lvl1pPr>
          </a:lstStyle>
          <a:p>
            <a:endParaRPr lang="en-GB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901698" y="0"/>
            <a:ext cx="2984871" cy="502755"/>
          </a:xfrm>
          <a:prstGeom prst="rect">
            <a:avLst/>
          </a:prstGeom>
        </p:spPr>
        <p:txBody>
          <a:bodyPr vert="horz" lIns="96616" tIns="48308" rIns="96616" bIns="48308" rtlCol="0"/>
          <a:lstStyle>
            <a:lvl1pPr algn="r">
              <a:defRPr sz="1300"/>
            </a:lvl1pPr>
          </a:lstStyle>
          <a:p>
            <a:fld id="{247F4D47-3D6E-4053-864A-9A1B552B9EAD}" type="datetimeFigureOut">
              <a:rPr lang="en-GB" smtClean="0"/>
              <a:t>01/08/2018</a:t>
            </a:fld>
            <a:endParaRPr lang="en-GB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90625" y="1252538"/>
            <a:ext cx="4506913" cy="33813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6616" tIns="48308" rIns="96616" bIns="48308" rtlCol="0" anchor="ctr"/>
          <a:lstStyle/>
          <a:p>
            <a:endParaRPr lang="en-GB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8817" y="4822269"/>
            <a:ext cx="5510530" cy="3945493"/>
          </a:xfrm>
          <a:prstGeom prst="rect">
            <a:avLst/>
          </a:prstGeom>
        </p:spPr>
        <p:txBody>
          <a:bodyPr vert="horz" lIns="96616" tIns="48308" rIns="96616" bIns="48308" rtlCol="0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GB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517547"/>
            <a:ext cx="2984871" cy="502754"/>
          </a:xfrm>
          <a:prstGeom prst="rect">
            <a:avLst/>
          </a:prstGeom>
        </p:spPr>
        <p:txBody>
          <a:bodyPr vert="horz" lIns="96616" tIns="48308" rIns="96616" bIns="48308" rtlCol="0" anchor="b"/>
          <a:lstStyle>
            <a:lvl1pPr algn="l">
              <a:defRPr sz="1300"/>
            </a:lvl1pPr>
          </a:lstStyle>
          <a:p>
            <a:endParaRPr lang="en-GB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901698" y="9517547"/>
            <a:ext cx="2984871" cy="502754"/>
          </a:xfrm>
          <a:prstGeom prst="rect">
            <a:avLst/>
          </a:prstGeom>
        </p:spPr>
        <p:txBody>
          <a:bodyPr vert="horz" lIns="96616" tIns="48308" rIns="96616" bIns="48308" rtlCol="0" anchor="b"/>
          <a:lstStyle>
            <a:lvl1pPr algn="r">
              <a:defRPr sz="1300"/>
            </a:lvl1pPr>
          </a:lstStyle>
          <a:p>
            <a:fld id="{C6B1AE9E-4C91-422A-B887-87B95C3F927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8665812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1190625" y="1252538"/>
            <a:ext cx="4506913" cy="3381375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6B1AE9E-4C91-422A-B887-87B95C3F927A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2248434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85A91C-7EF6-4DAF-8946-A2509F5E4410}" type="datetimeFigureOut">
              <a:rPr lang="en-GB" smtClean="0"/>
              <a:t>01/08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0699E0-CFC1-4738-93DB-8E650156D64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597179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85A91C-7EF6-4DAF-8946-A2509F5E4410}" type="datetimeFigureOut">
              <a:rPr lang="en-GB" smtClean="0"/>
              <a:t>01/08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0699E0-CFC1-4738-93DB-8E650156D64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239748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85A91C-7EF6-4DAF-8946-A2509F5E4410}" type="datetimeFigureOut">
              <a:rPr lang="en-GB" smtClean="0"/>
              <a:t>01/08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0699E0-CFC1-4738-93DB-8E650156D64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955909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85A91C-7EF6-4DAF-8946-A2509F5E4410}" type="datetimeFigureOut">
              <a:rPr lang="en-GB" smtClean="0"/>
              <a:t>01/08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0699E0-CFC1-4738-93DB-8E650156D64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192505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85A91C-7EF6-4DAF-8946-A2509F5E4410}" type="datetimeFigureOut">
              <a:rPr lang="en-GB" smtClean="0"/>
              <a:t>01/08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0699E0-CFC1-4738-93DB-8E650156D64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692812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85A91C-7EF6-4DAF-8946-A2509F5E4410}" type="datetimeFigureOut">
              <a:rPr lang="en-GB" smtClean="0"/>
              <a:t>01/08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0699E0-CFC1-4738-93DB-8E650156D64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69262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85A91C-7EF6-4DAF-8946-A2509F5E4410}" type="datetimeFigureOut">
              <a:rPr lang="en-GB" smtClean="0"/>
              <a:t>01/08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0699E0-CFC1-4738-93DB-8E650156D64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732435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85A91C-7EF6-4DAF-8946-A2509F5E4410}" type="datetimeFigureOut">
              <a:rPr lang="en-GB" smtClean="0"/>
              <a:t>01/08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0699E0-CFC1-4738-93DB-8E650156D64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296710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85A91C-7EF6-4DAF-8946-A2509F5E4410}" type="datetimeFigureOut">
              <a:rPr lang="en-GB" smtClean="0"/>
              <a:t>01/08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0699E0-CFC1-4738-93DB-8E650156D64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10673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85A91C-7EF6-4DAF-8946-A2509F5E4410}" type="datetimeFigureOut">
              <a:rPr lang="en-GB" smtClean="0"/>
              <a:t>01/08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0699E0-CFC1-4738-93DB-8E650156D64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554469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85A91C-7EF6-4DAF-8946-A2509F5E4410}" type="datetimeFigureOut">
              <a:rPr lang="en-GB" smtClean="0"/>
              <a:t>01/08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0699E0-CFC1-4738-93DB-8E650156D64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281415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85A91C-7EF6-4DAF-8946-A2509F5E4410}" type="datetimeFigureOut">
              <a:rPr lang="en-GB" smtClean="0"/>
              <a:t>01/08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0699E0-CFC1-4738-93DB-8E650156D64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229132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正方形/長方形 4"/>
          <p:cNvSpPr/>
          <p:nvPr/>
        </p:nvSpPr>
        <p:spPr>
          <a:xfrm>
            <a:off x="-99767" y="3003172"/>
            <a:ext cx="582661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l-G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μ</a:t>
            </a:r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/</a:t>
            </a:r>
            <a:r>
              <a:rPr lang="en-US" sz="10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m</a:t>
            </a:r>
            <a:r>
              <a:rPr lang="en-US" sz="1000" kern="100" baseline="300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3</a:t>
            </a:r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GB" sz="1000" kern="100" dirty="0"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  <p:sp>
        <p:nvSpPr>
          <p:cNvPr id="6" name="正方形/長方形 5"/>
          <p:cNvSpPr/>
          <p:nvPr/>
        </p:nvSpPr>
        <p:spPr>
          <a:xfrm>
            <a:off x="1922301" y="463637"/>
            <a:ext cx="559967" cy="22018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83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nter 1</a:t>
            </a:r>
          </a:p>
        </p:txBody>
      </p:sp>
      <p:sp>
        <p:nvSpPr>
          <p:cNvPr id="7" name="正方形/長方形 6"/>
          <p:cNvSpPr/>
          <p:nvPr/>
        </p:nvSpPr>
        <p:spPr>
          <a:xfrm>
            <a:off x="808310" y="461211"/>
            <a:ext cx="607639" cy="22018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83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utumn 1</a:t>
            </a:r>
          </a:p>
        </p:txBody>
      </p:sp>
      <p:sp>
        <p:nvSpPr>
          <p:cNvPr id="8" name="正方形/長方形 7"/>
          <p:cNvSpPr/>
          <p:nvPr/>
        </p:nvSpPr>
        <p:spPr>
          <a:xfrm>
            <a:off x="3096548" y="462390"/>
            <a:ext cx="632303" cy="22018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83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ring 1</a:t>
            </a:r>
          </a:p>
        </p:txBody>
      </p:sp>
      <p:sp>
        <p:nvSpPr>
          <p:cNvPr id="9" name="正方形/長方形 8"/>
          <p:cNvSpPr/>
          <p:nvPr/>
        </p:nvSpPr>
        <p:spPr>
          <a:xfrm>
            <a:off x="4335860" y="462386"/>
            <a:ext cx="624669" cy="22018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83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mmer</a:t>
            </a:r>
            <a:endParaRPr lang="en-GB" sz="831" kern="100" dirty="0"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  <p:sp>
        <p:nvSpPr>
          <p:cNvPr id="10" name="正方形/長方形 9"/>
          <p:cNvSpPr/>
          <p:nvPr/>
        </p:nvSpPr>
        <p:spPr>
          <a:xfrm>
            <a:off x="5474491" y="462387"/>
            <a:ext cx="607639" cy="22018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83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utumn 2</a:t>
            </a:r>
          </a:p>
        </p:txBody>
      </p:sp>
      <p:sp>
        <p:nvSpPr>
          <p:cNvPr id="11" name="正方形/長方形 10"/>
          <p:cNvSpPr/>
          <p:nvPr/>
        </p:nvSpPr>
        <p:spPr>
          <a:xfrm>
            <a:off x="6702945" y="462392"/>
            <a:ext cx="695382" cy="22018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83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nter 2</a:t>
            </a:r>
          </a:p>
        </p:txBody>
      </p:sp>
      <p:sp>
        <p:nvSpPr>
          <p:cNvPr id="12" name="正方形/長方形 11"/>
          <p:cNvSpPr/>
          <p:nvPr/>
        </p:nvSpPr>
        <p:spPr>
          <a:xfrm>
            <a:off x="7867012" y="464123"/>
            <a:ext cx="576343" cy="22018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83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ring 2</a:t>
            </a:r>
          </a:p>
        </p:txBody>
      </p:sp>
      <p:sp>
        <p:nvSpPr>
          <p:cNvPr id="3" name="正方形/長方形 2"/>
          <p:cNvSpPr/>
          <p:nvPr/>
        </p:nvSpPr>
        <p:spPr>
          <a:xfrm>
            <a:off x="70122" y="140573"/>
            <a:ext cx="28405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400" b="1" dirty="0">
                <a:latin typeface="Arial" panose="020B0604020202020204" pitchFamily="34" charset="0"/>
                <a:ea typeface="HGPｺﾞｼｯｸE" panose="020B0900000000000000" pitchFamily="50" charset="-128"/>
                <a:cs typeface="Arial" panose="020B0604020202020204" pitchFamily="34" charset="0"/>
              </a:rPr>
              <a:t>a</a:t>
            </a:r>
            <a:endParaRPr lang="en-GB" sz="1400" dirty="0">
              <a:latin typeface="Arial" panose="020B0604020202020204" pitchFamily="34" charset="0"/>
              <a:ea typeface="HGPｺﾞｼｯｸE" panose="020B09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3" name="正方形/長方形 12"/>
          <p:cNvSpPr/>
          <p:nvPr/>
        </p:nvSpPr>
        <p:spPr>
          <a:xfrm>
            <a:off x="51176" y="2779862"/>
            <a:ext cx="293670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400" b="1" dirty="0">
                <a:latin typeface="Arial" panose="020B0604020202020204" pitchFamily="34" charset="0"/>
                <a:ea typeface="HGPｺﾞｼｯｸE" panose="020B0900000000000000" pitchFamily="50" charset="-128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2" name="正方形/長方形 21"/>
          <p:cNvSpPr/>
          <p:nvPr/>
        </p:nvSpPr>
        <p:spPr>
          <a:xfrm>
            <a:off x="1908945" y="3113313"/>
            <a:ext cx="559967" cy="22018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83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nter 1</a:t>
            </a:r>
          </a:p>
        </p:txBody>
      </p:sp>
      <p:sp>
        <p:nvSpPr>
          <p:cNvPr id="23" name="正方形/長方形 22"/>
          <p:cNvSpPr/>
          <p:nvPr/>
        </p:nvSpPr>
        <p:spPr>
          <a:xfrm>
            <a:off x="794954" y="3110887"/>
            <a:ext cx="607639" cy="22018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83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utumn 1</a:t>
            </a:r>
          </a:p>
        </p:txBody>
      </p:sp>
      <p:sp>
        <p:nvSpPr>
          <p:cNvPr id="24" name="正方形/長方形 23"/>
          <p:cNvSpPr/>
          <p:nvPr/>
        </p:nvSpPr>
        <p:spPr>
          <a:xfrm>
            <a:off x="3083191" y="3112066"/>
            <a:ext cx="633785" cy="22018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83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ring 1</a:t>
            </a:r>
          </a:p>
        </p:txBody>
      </p:sp>
      <p:sp>
        <p:nvSpPr>
          <p:cNvPr id="25" name="正方形/長方形 24"/>
          <p:cNvSpPr/>
          <p:nvPr/>
        </p:nvSpPr>
        <p:spPr>
          <a:xfrm>
            <a:off x="4322504" y="3112062"/>
            <a:ext cx="624669" cy="22018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83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mmer</a:t>
            </a:r>
            <a:endParaRPr lang="en-GB" sz="831" kern="100" dirty="0"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  <p:sp>
        <p:nvSpPr>
          <p:cNvPr id="26" name="正方形/長方形 25"/>
          <p:cNvSpPr/>
          <p:nvPr/>
        </p:nvSpPr>
        <p:spPr>
          <a:xfrm>
            <a:off x="5461135" y="3112063"/>
            <a:ext cx="607639" cy="22018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83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utumn 2</a:t>
            </a:r>
          </a:p>
        </p:txBody>
      </p:sp>
      <p:sp>
        <p:nvSpPr>
          <p:cNvPr id="27" name="正方形/長方形 26"/>
          <p:cNvSpPr/>
          <p:nvPr/>
        </p:nvSpPr>
        <p:spPr>
          <a:xfrm>
            <a:off x="6689588" y="3112067"/>
            <a:ext cx="601861" cy="22018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83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nter 2</a:t>
            </a:r>
          </a:p>
        </p:txBody>
      </p:sp>
      <p:sp>
        <p:nvSpPr>
          <p:cNvPr id="28" name="正方形/長方形 27"/>
          <p:cNvSpPr/>
          <p:nvPr/>
        </p:nvSpPr>
        <p:spPr>
          <a:xfrm>
            <a:off x="7853656" y="3113799"/>
            <a:ext cx="589699" cy="22018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83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ring 2</a:t>
            </a:r>
          </a:p>
        </p:txBody>
      </p:sp>
      <p:sp>
        <p:nvSpPr>
          <p:cNvPr id="37" name="正方形/長方形 36"/>
          <p:cNvSpPr/>
          <p:nvPr/>
        </p:nvSpPr>
        <p:spPr>
          <a:xfrm>
            <a:off x="-101743" y="341120"/>
            <a:ext cx="582661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l-G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μ</a:t>
            </a:r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/</a:t>
            </a:r>
            <a:r>
              <a:rPr lang="en-US" sz="10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m</a:t>
            </a:r>
            <a:r>
              <a:rPr lang="en-US" sz="1000" kern="100" baseline="300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3</a:t>
            </a:r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GB" sz="1000" kern="100" dirty="0"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  <p:graphicFrame>
        <p:nvGraphicFramePr>
          <p:cNvPr id="52" name="グラフ 5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35341422"/>
              </p:ext>
            </p:extLst>
          </p:nvPr>
        </p:nvGraphicFramePr>
        <p:xfrm>
          <a:off x="188459" y="169223"/>
          <a:ext cx="8587406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54" name="グラフ 5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94541130"/>
              </p:ext>
            </p:extLst>
          </p:nvPr>
        </p:nvGraphicFramePr>
        <p:xfrm>
          <a:off x="115228" y="2959925"/>
          <a:ext cx="8743764" cy="310836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cxnSp>
        <p:nvCxnSpPr>
          <p:cNvPr id="39" name="直線矢印コネクタ 38"/>
          <p:cNvCxnSpPr/>
          <p:nvPr/>
        </p:nvCxnSpPr>
        <p:spPr>
          <a:xfrm>
            <a:off x="1559857" y="657322"/>
            <a:ext cx="1155971" cy="3590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直線矢印コネクタ 42"/>
          <p:cNvCxnSpPr/>
          <p:nvPr/>
        </p:nvCxnSpPr>
        <p:spPr>
          <a:xfrm>
            <a:off x="2716730" y="656237"/>
            <a:ext cx="1177537" cy="1085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直線矢印コネクタ 45"/>
          <p:cNvCxnSpPr/>
          <p:nvPr/>
        </p:nvCxnSpPr>
        <p:spPr>
          <a:xfrm flipV="1">
            <a:off x="3905024" y="657328"/>
            <a:ext cx="1280161" cy="5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直線矢印コネクタ 46"/>
          <p:cNvCxnSpPr/>
          <p:nvPr/>
        </p:nvCxnSpPr>
        <p:spPr>
          <a:xfrm>
            <a:off x="5195943" y="657322"/>
            <a:ext cx="1182152" cy="3587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直線矢印コネクタ 47"/>
          <p:cNvCxnSpPr/>
          <p:nvPr/>
        </p:nvCxnSpPr>
        <p:spPr>
          <a:xfrm>
            <a:off x="7524558" y="649034"/>
            <a:ext cx="1210736" cy="1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直線矢印コネクタ 48"/>
          <p:cNvCxnSpPr/>
          <p:nvPr/>
        </p:nvCxnSpPr>
        <p:spPr>
          <a:xfrm flipV="1">
            <a:off x="6379285" y="656240"/>
            <a:ext cx="1141044" cy="1088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直線矢印コネクタ 49"/>
          <p:cNvCxnSpPr/>
          <p:nvPr/>
        </p:nvCxnSpPr>
        <p:spPr>
          <a:xfrm>
            <a:off x="503183" y="654269"/>
            <a:ext cx="1057792" cy="3053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8" name="直線矢印コネクタ 77"/>
          <p:cNvCxnSpPr/>
          <p:nvPr/>
        </p:nvCxnSpPr>
        <p:spPr>
          <a:xfrm>
            <a:off x="1518614" y="3325895"/>
            <a:ext cx="1155971" cy="3590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" name="直線矢印コネクタ 78"/>
          <p:cNvCxnSpPr/>
          <p:nvPr/>
        </p:nvCxnSpPr>
        <p:spPr>
          <a:xfrm>
            <a:off x="2675487" y="3324810"/>
            <a:ext cx="1177537" cy="1085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0" name="直線矢印コネクタ 79"/>
          <p:cNvCxnSpPr/>
          <p:nvPr/>
        </p:nvCxnSpPr>
        <p:spPr>
          <a:xfrm flipV="1">
            <a:off x="3863781" y="3325901"/>
            <a:ext cx="1280161" cy="5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直線矢印コネクタ 80"/>
          <p:cNvCxnSpPr/>
          <p:nvPr/>
        </p:nvCxnSpPr>
        <p:spPr>
          <a:xfrm>
            <a:off x="5143942" y="3325895"/>
            <a:ext cx="1182152" cy="3587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" name="直線矢印コネクタ 81"/>
          <p:cNvCxnSpPr/>
          <p:nvPr/>
        </p:nvCxnSpPr>
        <p:spPr>
          <a:xfrm>
            <a:off x="7481454" y="3325091"/>
            <a:ext cx="1175657" cy="0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直線矢印コネクタ 82"/>
          <p:cNvCxnSpPr/>
          <p:nvPr/>
        </p:nvCxnSpPr>
        <p:spPr>
          <a:xfrm flipV="1">
            <a:off x="6327284" y="3324813"/>
            <a:ext cx="1141044" cy="1088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" name="直線矢印コネクタ 83"/>
          <p:cNvCxnSpPr/>
          <p:nvPr/>
        </p:nvCxnSpPr>
        <p:spPr>
          <a:xfrm>
            <a:off x="461940" y="3322842"/>
            <a:ext cx="1057792" cy="3053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正方形/長方形 37">
            <a:extLst>
              <a:ext uri="{FF2B5EF4-FFF2-40B4-BE49-F238E27FC236}">
                <a16:creationId xmlns:a16="http://schemas.microsoft.com/office/drawing/2014/main" id="{F4221AD1-CD74-4F48-A7AE-58CA877EC1C7}"/>
              </a:ext>
            </a:extLst>
          </p:cNvPr>
          <p:cNvSpPr/>
          <p:nvPr/>
        </p:nvSpPr>
        <p:spPr>
          <a:xfrm>
            <a:off x="3802123" y="6386971"/>
            <a:ext cx="5252219" cy="338554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lvl="0"/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hammad Shahriar Khan </a:t>
            </a:r>
            <a:r>
              <a:rPr lang="en-US" altLang="ja-JP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t al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,</a:t>
            </a:r>
            <a:r>
              <a:rPr lang="en-GB" altLang="ja-JP" sz="16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Additional file: Figure S</a:t>
            </a:r>
            <a:r>
              <a:rPr lang="en-GB" sz="16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</a:p>
        </p:txBody>
      </p:sp>
    </p:spTree>
    <p:extLst>
      <p:ext uri="{BB962C8B-B14F-4D97-AF65-F5344CB8AC3E}">
        <p14:creationId xmlns:p14="http://schemas.microsoft.com/office/powerpoint/2010/main" val="39586852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98</TotalTime>
  <Words>52</Words>
  <Application>Microsoft Office PowerPoint</Application>
  <PresentationFormat>画面に合わせる (4:3)</PresentationFormat>
  <Paragraphs>20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7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9" baseType="lpstr">
      <vt:lpstr>HGPｺﾞｼｯｸE</vt:lpstr>
      <vt:lpstr>ＭＳ Ｐゴシック</vt:lpstr>
      <vt:lpstr>ＭＳ 明朝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hasei</dc:creator>
  <cp:lastModifiedBy>watanabe tetsushi</cp:lastModifiedBy>
  <cp:revision>57</cp:revision>
  <cp:lastPrinted>2018-06-11T10:54:54Z</cp:lastPrinted>
  <dcterms:created xsi:type="dcterms:W3CDTF">2018-05-16T09:38:02Z</dcterms:created>
  <dcterms:modified xsi:type="dcterms:W3CDTF">2018-08-01T03:19:03Z</dcterms:modified>
</cp:coreProperties>
</file>